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B882"/>
    <a:srgbClr val="354F5F"/>
    <a:srgbClr val="485063"/>
    <a:srgbClr val="343D52"/>
    <a:srgbClr val="152538"/>
    <a:srgbClr val="0C2D4C"/>
    <a:srgbClr val="2D3E55"/>
    <a:srgbClr val="011893"/>
    <a:srgbClr val="0054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694"/>
  </p:normalViewPr>
  <p:slideViewPr>
    <p:cSldViewPr snapToGrid="0" snapToObjects="1">
      <p:cViewPr varScale="1">
        <p:scale>
          <a:sx n="107" d="100"/>
          <a:sy n="107" d="100"/>
        </p:scale>
        <p:origin x="498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TheTxIDJournal  @hassamalii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4855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Hassam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2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3"/>
            <a:ext cx="1192347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ative Analysis and Trends in Liver Transplant hospitalizations with Clostridium difficile Infections: A 10-year National Cross-sectional Study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 descr="A picture containing icon&#10;&#10;Description automatically generated">
            <a:extLst>
              <a:ext uri="{FF2B5EF4-FFF2-40B4-BE49-F238E27FC236}">
                <a16:creationId xmlns:a16="http://schemas.microsoft.com/office/drawing/2014/main" id="{103FDC54-1975-41D3-B053-5D8A9F88E0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10967" y="1809995"/>
            <a:ext cx="2099465" cy="132343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72A7141F-1780-421B-8287-B18D282C29DF}"/>
              </a:ext>
            </a:extLst>
          </p:cNvPr>
          <p:cNvSpPr txBox="1"/>
          <p:nvPr/>
        </p:nvSpPr>
        <p:spPr>
          <a:xfrm>
            <a:off x="363157" y="3621370"/>
            <a:ext cx="3868184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4.05% decrease in Clostridium difficile Infections in hospitalizations with liver transplant from 2009 to 2019.</a:t>
            </a:r>
          </a:p>
        </p:txBody>
      </p:sp>
      <p:pic>
        <p:nvPicPr>
          <p:cNvPr id="28" name="Picture 27" descr="Shape, circle&#10;&#10;Description automatically generated">
            <a:extLst>
              <a:ext uri="{FF2B5EF4-FFF2-40B4-BE49-F238E27FC236}">
                <a16:creationId xmlns:a16="http://schemas.microsoft.com/office/drawing/2014/main" id="{1ABA4863-7132-40E4-B01C-D5442814ACC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44296">
            <a:off x="5365543" y="1436071"/>
            <a:ext cx="1345318" cy="151194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942339FC-8229-468C-A943-CCFCE168CD70}"/>
              </a:ext>
            </a:extLst>
          </p:cNvPr>
          <p:cNvSpPr txBox="1"/>
          <p:nvPr/>
        </p:nvSpPr>
        <p:spPr>
          <a:xfrm>
            <a:off x="4471693" y="3616960"/>
            <a:ext cx="3609953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iver transplant</a:t>
            </a: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ospitalizations of autoimmune etiology compared against non-autoimmune do not have increase association with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lostridium difficile Infections.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075E23B-3AE3-43B1-B638-1ABB2132A272}"/>
              </a:ext>
            </a:extLst>
          </p:cNvPr>
          <p:cNvSpPr txBox="1"/>
          <p:nvPr/>
        </p:nvSpPr>
        <p:spPr>
          <a:xfrm>
            <a:off x="9210967" y="3481557"/>
            <a:ext cx="229754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lostridium difficile Infections is associated with increased mortality and liver transplant rejections </a:t>
            </a:r>
            <a:endParaRPr lang="en-US" sz="1600" dirty="0"/>
          </a:p>
        </p:txBody>
      </p:sp>
      <p:pic>
        <p:nvPicPr>
          <p:cNvPr id="36" name="Picture 35" descr="Chart&#10;&#10;Description automatically generated">
            <a:extLst>
              <a:ext uri="{FF2B5EF4-FFF2-40B4-BE49-F238E27FC236}">
                <a16:creationId xmlns:a16="http://schemas.microsoft.com/office/drawing/2014/main" id="{BC19BFF6-C4AC-46B3-9D44-787EE4E61A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3157" y="1461575"/>
            <a:ext cx="3750414" cy="1856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29</TotalTime>
  <Words>81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Ali, Hassam</cp:lastModifiedBy>
  <cp:revision>14</cp:revision>
  <dcterms:created xsi:type="dcterms:W3CDTF">2021-10-22T20:34:26Z</dcterms:created>
  <dcterms:modified xsi:type="dcterms:W3CDTF">2022-09-30T01:2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